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1" r:id="rId3"/>
    <p:sldId id="263" r:id="rId4"/>
    <p:sldId id="265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2107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6C981-8978-427A-88AD-6A6AA17A9F06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443E-4E1E-4FFF-8029-6636029AABB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77292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6C981-8978-427A-88AD-6A6AA17A9F06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443E-4E1E-4FFF-8029-6636029AABB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75741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6C981-8978-427A-88AD-6A6AA17A9F06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443E-4E1E-4FFF-8029-6636029AABB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3539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6C981-8978-427A-88AD-6A6AA17A9F06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443E-4E1E-4FFF-8029-6636029AABB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3364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6C981-8978-427A-88AD-6A6AA17A9F06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443E-4E1E-4FFF-8029-6636029AABB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56341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6C981-8978-427A-88AD-6A6AA17A9F06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443E-4E1E-4FFF-8029-6636029AABB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7722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6C981-8978-427A-88AD-6A6AA17A9F06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443E-4E1E-4FFF-8029-6636029AABB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6989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6C981-8978-427A-88AD-6A6AA17A9F06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443E-4E1E-4FFF-8029-6636029AABB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67499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6C981-8978-427A-88AD-6A6AA17A9F06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443E-4E1E-4FFF-8029-6636029AABB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1061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6C981-8978-427A-88AD-6A6AA17A9F06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443E-4E1E-4FFF-8029-6636029AABB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6459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6C981-8978-427A-88AD-6A6AA17A9F06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7443E-4E1E-4FFF-8029-6636029AABB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11425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E6C981-8978-427A-88AD-6A6AA17A9F06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7443E-4E1E-4FFF-8029-6636029AABB5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5186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280270" y="288099"/>
            <a:ext cx="6172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le 1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list of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in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vel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enolic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und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ir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rivative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control and </a:t>
            </a:r>
            <a:r>
              <a:rPr lang="it-IT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N4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RC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aphicFrame>
        <p:nvGraphicFramePr>
          <p:cNvPr id="6" name="Oggetto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437763"/>
              </p:ext>
            </p:extLst>
          </p:nvPr>
        </p:nvGraphicFramePr>
        <p:xfrm>
          <a:off x="782659" y="749764"/>
          <a:ext cx="5518150" cy="425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Prism 8" r:id="rId3" imgW="5517739" imgH="4251507" progId="Prism8.Document">
                  <p:embed/>
                </p:oleObj>
              </mc:Choice>
              <mc:Fallback>
                <p:oleObj name="Prism 8" r:id="rId3" imgW="5517739" imgH="4251507" progId="Prism8.Document">
                  <p:embed/>
                  <p:pic>
                    <p:nvPicPr>
                      <p:cNvPr id="2" name="Oggetto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82659" y="749764"/>
                        <a:ext cx="5518150" cy="425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ggetto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8073672"/>
              </p:ext>
            </p:extLst>
          </p:nvPr>
        </p:nvGraphicFramePr>
        <p:xfrm>
          <a:off x="782659" y="5357595"/>
          <a:ext cx="5518150" cy="425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Prism 8" r:id="rId5" imgW="5517739" imgH="4251507" progId="Prism8.Document">
                  <p:embed/>
                </p:oleObj>
              </mc:Choice>
              <mc:Fallback>
                <p:oleObj name="Prism 8" r:id="rId5" imgW="5517739" imgH="4251507" progId="Prism8.Document">
                  <p:embed/>
                  <p:pic>
                    <p:nvPicPr>
                      <p:cNvPr id="2" name="Oggetto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82659" y="5357595"/>
                        <a:ext cx="5518150" cy="425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303701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6349552"/>
              </p:ext>
            </p:extLst>
          </p:nvPr>
        </p:nvGraphicFramePr>
        <p:xfrm>
          <a:off x="694977" y="297081"/>
          <a:ext cx="5518150" cy="425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6" name="Prism 8" r:id="rId3" imgW="5517739" imgH="4251507" progId="Prism8.Document">
                  <p:embed/>
                </p:oleObj>
              </mc:Choice>
              <mc:Fallback>
                <p:oleObj name="Prism 8" r:id="rId3" imgW="5517739" imgH="425150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4977" y="297081"/>
                        <a:ext cx="5518150" cy="425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gget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9893397"/>
              </p:ext>
            </p:extLst>
          </p:nvPr>
        </p:nvGraphicFramePr>
        <p:xfrm>
          <a:off x="694977" y="4781399"/>
          <a:ext cx="5518150" cy="425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7" name="Prism 8" r:id="rId5" imgW="5517739" imgH="4251507" progId="Prism8.Document">
                  <p:embed/>
                </p:oleObj>
              </mc:Choice>
              <mc:Fallback>
                <p:oleObj name="Prism 8" r:id="rId5" imgW="5517739" imgH="4251507" progId="Prism8.Document">
                  <p:embed/>
                  <p:pic>
                    <p:nvPicPr>
                      <p:cNvPr id="2" name="Oggetto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94977" y="4781399"/>
                        <a:ext cx="5518150" cy="425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510119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2891005"/>
              </p:ext>
            </p:extLst>
          </p:nvPr>
        </p:nvGraphicFramePr>
        <p:xfrm>
          <a:off x="720029" y="397288"/>
          <a:ext cx="5518150" cy="425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0" name="Prism 8" r:id="rId3" imgW="5517739" imgH="4251507" progId="Prism8.Document">
                  <p:embed/>
                </p:oleObj>
              </mc:Choice>
              <mc:Fallback>
                <p:oleObj name="Prism 8" r:id="rId3" imgW="5517739" imgH="425150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20029" y="397288"/>
                        <a:ext cx="5518150" cy="425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gget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3994002"/>
              </p:ext>
            </p:extLst>
          </p:nvPr>
        </p:nvGraphicFramePr>
        <p:xfrm>
          <a:off x="720029" y="5157179"/>
          <a:ext cx="5518150" cy="425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1" name="Prism 8" r:id="rId5" imgW="5517739" imgH="4251507" progId="Prism8.Document">
                  <p:embed/>
                </p:oleObj>
              </mc:Choice>
              <mc:Fallback>
                <p:oleObj name="Prism 8" r:id="rId5" imgW="5517739" imgH="4251507" progId="Prism8.Document">
                  <p:embed/>
                  <p:pic>
                    <p:nvPicPr>
                      <p:cNvPr id="2" name="Oggetto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20029" y="5157179"/>
                        <a:ext cx="5518150" cy="425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754839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6751796"/>
              </p:ext>
            </p:extLst>
          </p:nvPr>
        </p:nvGraphicFramePr>
        <p:xfrm>
          <a:off x="669925" y="2827338"/>
          <a:ext cx="5518150" cy="4251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2" name="Prism 8" r:id="rId3" imgW="5517739" imgH="4251507" progId="Prism8.Document">
                  <p:embed/>
                </p:oleObj>
              </mc:Choice>
              <mc:Fallback>
                <p:oleObj name="Prism 8" r:id="rId3" imgW="5517739" imgH="425150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69925" y="2827338"/>
                        <a:ext cx="5518150" cy="4251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4183349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23</Words>
  <Application>Microsoft Office PowerPoint</Application>
  <PresentationFormat>A4 (21x29,7 cm)</PresentationFormat>
  <Paragraphs>1</Paragraphs>
  <Slides>4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ema di Office</vt:lpstr>
      <vt:lpstr>Prism 8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iccardo Pagliarello</dc:creator>
  <cp:lastModifiedBy>Riccardo Pagliarello</cp:lastModifiedBy>
  <cp:revision>6</cp:revision>
  <dcterms:created xsi:type="dcterms:W3CDTF">2021-09-19T11:12:50Z</dcterms:created>
  <dcterms:modified xsi:type="dcterms:W3CDTF">2021-11-12T12:11:36Z</dcterms:modified>
</cp:coreProperties>
</file>